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68" d="100"/>
          <a:sy n="68" d="100"/>
        </p:scale>
        <p:origin x="3174" y="27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4688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59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428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7304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24133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030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43988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27184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372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02236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3203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59C373A-D674-4D73-A79B-2E75A1E88F62}" type="datetimeFigureOut">
              <a:rPr lang="en-US" smtClean="0"/>
              <a:t>4/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CF707A-B346-4AB5-82AC-14C73A8624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4349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>
            <a:extLst>
              <a:ext uri="{FF2B5EF4-FFF2-40B4-BE49-F238E27FC236}">
                <a16:creationId xmlns:a16="http://schemas.microsoft.com/office/drawing/2014/main" id="{C47E90AA-CAA4-4F41-9D60-B990127A4D3C}"/>
              </a:ext>
            </a:extLst>
          </p:cNvPr>
          <p:cNvGrpSpPr/>
          <p:nvPr/>
        </p:nvGrpSpPr>
        <p:grpSpPr>
          <a:xfrm>
            <a:off x="479323" y="501445"/>
            <a:ext cx="6413846" cy="8009509"/>
            <a:chOff x="479323" y="501445"/>
            <a:chExt cx="6413846" cy="8009509"/>
          </a:xfrm>
        </p:grpSpPr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3BFE9B0F-4D2D-46E4-AA22-8C6DA0FC2AB5}"/>
                </a:ext>
              </a:extLst>
            </p:cNvPr>
            <p:cNvSpPr/>
            <p:nvPr/>
          </p:nvSpPr>
          <p:spPr>
            <a:xfrm>
              <a:off x="479323" y="501445"/>
              <a:ext cx="6413846" cy="800950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6" name="Picture 5" descr="A collage of images of a nuclear explosion&#10;&#10;Description automatically generated">
              <a:extLst>
                <a:ext uri="{FF2B5EF4-FFF2-40B4-BE49-F238E27FC236}">
                  <a16:creationId xmlns:a16="http://schemas.microsoft.com/office/drawing/2014/main" id="{D77DFE3A-9A7C-44E9-8E55-04CA86A8BE2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094231" y="824248"/>
              <a:ext cx="4769803" cy="2305319"/>
            </a:xfrm>
            <a:prstGeom prst="rect">
              <a:avLst/>
            </a:prstGeom>
          </p:spPr>
        </p:pic>
        <p:pic>
          <p:nvPicPr>
            <p:cNvPr id="7" name="Picture 6" descr="A close-up of a blue and green object&#10;&#10;Description automatically generated with medium confidence">
              <a:extLst>
                <a:ext uri="{FF2B5EF4-FFF2-40B4-BE49-F238E27FC236}">
                  <a16:creationId xmlns:a16="http://schemas.microsoft.com/office/drawing/2014/main" id="{7A310186-A992-4525-86E2-FC6469BC34E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911761" y="3272059"/>
              <a:ext cx="4773168" cy="1140724"/>
            </a:xfrm>
            <a:prstGeom prst="rect">
              <a:avLst/>
            </a:prstGeom>
          </p:spPr>
        </p:pic>
        <p:pic>
          <p:nvPicPr>
            <p:cNvPr id="8" name="Picture 7" descr="A collage of images of a person's body&#10;&#10;Description automatically generated">
              <a:extLst>
                <a:ext uri="{FF2B5EF4-FFF2-40B4-BE49-F238E27FC236}">
                  <a16:creationId xmlns:a16="http://schemas.microsoft.com/office/drawing/2014/main" id="{BB470797-581C-45FE-9987-60BCAE6E050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985458" y="4697362"/>
              <a:ext cx="3823743" cy="2447909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A69FA100-A5D0-43D2-AD91-5D1512B83526}"/>
                </a:ext>
              </a:extLst>
            </p:cNvPr>
            <p:cNvSpPr txBox="1"/>
            <p:nvPr/>
          </p:nvSpPr>
          <p:spPr>
            <a:xfrm>
              <a:off x="564524" y="953037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F5A8940-3A15-4AF1-8ACD-3EC17979F312}"/>
                </a:ext>
              </a:extLst>
            </p:cNvPr>
            <p:cNvSpPr txBox="1"/>
            <p:nvPr/>
          </p:nvSpPr>
          <p:spPr>
            <a:xfrm>
              <a:off x="564524" y="3449393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10F0ECD-3F95-4AE6-AB90-57A528E6573E}"/>
                </a:ext>
              </a:extLst>
            </p:cNvPr>
            <p:cNvSpPr txBox="1"/>
            <p:nvPr/>
          </p:nvSpPr>
          <p:spPr>
            <a:xfrm>
              <a:off x="564524" y="5404834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09A947D2-6861-4001-BA6A-9CC32A9D8535}"/>
                </a:ext>
              </a:extLst>
            </p:cNvPr>
            <p:cNvSpPr/>
            <p:nvPr/>
          </p:nvSpPr>
          <p:spPr>
            <a:xfrm>
              <a:off x="804011" y="7221178"/>
              <a:ext cx="5962549" cy="1015663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just"/>
              <a:r>
                <a:rPr lang="en-US" sz="1200" b="1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upplemental Figure 1: </a:t>
              </a:r>
              <a:r>
                <a:rPr lang="en-US" sz="12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low-cytometry gating strategy. Representative images for  the gating hierarchy in blood (A, B) and homogenized brain tissue. (</a:t>
              </a:r>
              <a:r>
                <a:rPr lang="en-US" sz="1200" b="1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r>
                <a:rPr lang="en-US" sz="12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 Outline of the gating strategy to identify B cells, T cells and NK cells in peripheral blood. (</a:t>
              </a:r>
              <a:r>
                <a:rPr lang="en-US" sz="1200" b="1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12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 Outline of the gating strategy for the cells of myeloid origin (</a:t>
              </a:r>
              <a:r>
                <a:rPr lang="en-US" sz="1200" b="1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en-US" sz="1200" dirty="0">
                  <a:solidFill>
                    <a:srgbClr val="11111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) Outline of the gating strategy for the immune cells obtained from the brain. </a:t>
              </a:r>
              <a:endParaRPr lang="en-US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711651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27</TotalTime>
  <Words>82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rnadette E. Grayson</dc:creator>
  <cp:lastModifiedBy>Bernadette E. Grayson</cp:lastModifiedBy>
  <cp:revision>8</cp:revision>
  <dcterms:created xsi:type="dcterms:W3CDTF">2024-04-04T15:54:19Z</dcterms:created>
  <dcterms:modified xsi:type="dcterms:W3CDTF">2024-04-04T21:22:16Z</dcterms:modified>
</cp:coreProperties>
</file>